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l-G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9" d="100"/>
          <a:sy n="99" d="100"/>
        </p:scale>
        <p:origin x="-288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l-G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DDEC9-814D-4DBE-8D07-A8439B0F84D4}" type="datetimeFigureOut">
              <a:rPr lang="el-GR" smtClean="0"/>
              <a:pPr/>
              <a:t>21/3/2019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AA2AFF-EDE6-484C-865A-76E04C78AAF7}" type="slidenum">
              <a:rPr lang="el-GR" smtClean="0"/>
              <a:pPr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DDEC9-814D-4DBE-8D07-A8439B0F84D4}" type="datetimeFigureOut">
              <a:rPr lang="el-GR" smtClean="0"/>
              <a:pPr/>
              <a:t>21/3/2019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AA2AFF-EDE6-484C-865A-76E04C78AAF7}" type="slidenum">
              <a:rPr lang="el-GR" smtClean="0"/>
              <a:pPr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DDEC9-814D-4DBE-8D07-A8439B0F84D4}" type="datetimeFigureOut">
              <a:rPr lang="el-GR" smtClean="0"/>
              <a:pPr/>
              <a:t>21/3/2019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AA2AFF-EDE6-484C-865A-76E04C78AAF7}" type="slidenum">
              <a:rPr lang="el-GR" smtClean="0"/>
              <a:pPr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DDEC9-814D-4DBE-8D07-A8439B0F84D4}" type="datetimeFigureOut">
              <a:rPr lang="el-GR" smtClean="0"/>
              <a:pPr/>
              <a:t>21/3/2019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AA2AFF-EDE6-484C-865A-76E04C78AAF7}" type="slidenum">
              <a:rPr lang="el-GR" smtClean="0"/>
              <a:pPr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DDEC9-814D-4DBE-8D07-A8439B0F84D4}" type="datetimeFigureOut">
              <a:rPr lang="el-GR" smtClean="0"/>
              <a:pPr/>
              <a:t>21/3/2019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AA2AFF-EDE6-484C-865A-76E04C78AAF7}" type="slidenum">
              <a:rPr lang="el-GR" smtClean="0"/>
              <a:pPr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DDEC9-814D-4DBE-8D07-A8439B0F84D4}" type="datetimeFigureOut">
              <a:rPr lang="el-GR" smtClean="0"/>
              <a:pPr/>
              <a:t>21/3/2019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AA2AFF-EDE6-484C-865A-76E04C78AAF7}" type="slidenum">
              <a:rPr lang="el-GR" smtClean="0"/>
              <a:pPr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DDEC9-814D-4DBE-8D07-A8439B0F84D4}" type="datetimeFigureOut">
              <a:rPr lang="el-GR" smtClean="0"/>
              <a:pPr/>
              <a:t>21/3/2019</a:t>
            </a:fld>
            <a:endParaRPr lang="el-G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AA2AFF-EDE6-484C-865A-76E04C78AAF7}" type="slidenum">
              <a:rPr lang="el-GR" smtClean="0"/>
              <a:pPr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DDEC9-814D-4DBE-8D07-A8439B0F84D4}" type="datetimeFigureOut">
              <a:rPr lang="el-GR" smtClean="0"/>
              <a:pPr/>
              <a:t>21/3/2019</a:t>
            </a:fld>
            <a:endParaRPr lang="el-G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AA2AFF-EDE6-484C-865A-76E04C78AAF7}" type="slidenum">
              <a:rPr lang="el-GR" smtClean="0"/>
              <a:pPr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DDEC9-814D-4DBE-8D07-A8439B0F84D4}" type="datetimeFigureOut">
              <a:rPr lang="el-GR" smtClean="0"/>
              <a:pPr/>
              <a:t>21/3/2019</a:t>
            </a:fld>
            <a:endParaRPr lang="el-G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AA2AFF-EDE6-484C-865A-76E04C78AAF7}" type="slidenum">
              <a:rPr lang="el-GR" smtClean="0"/>
              <a:pPr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DDEC9-814D-4DBE-8D07-A8439B0F84D4}" type="datetimeFigureOut">
              <a:rPr lang="el-GR" smtClean="0"/>
              <a:pPr/>
              <a:t>21/3/2019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AA2AFF-EDE6-484C-865A-76E04C78AAF7}" type="slidenum">
              <a:rPr lang="el-GR" smtClean="0"/>
              <a:pPr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l-GR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DDEC9-814D-4DBE-8D07-A8439B0F84D4}" type="datetimeFigureOut">
              <a:rPr lang="el-GR" smtClean="0"/>
              <a:pPr/>
              <a:t>21/3/2019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AA2AFF-EDE6-484C-865A-76E04C78AAF7}" type="slidenum">
              <a:rPr lang="el-GR" smtClean="0"/>
              <a:pPr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DDEC9-814D-4DBE-8D07-A8439B0F84D4}" type="datetimeFigureOut">
              <a:rPr lang="el-GR" smtClean="0"/>
              <a:pPr/>
              <a:t>21/3/2019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AA2AFF-EDE6-484C-865A-76E04C78AAF7}" type="slidenum">
              <a:rPr lang="el-GR" smtClean="0"/>
              <a:pPr/>
              <a:t>‹#›</a:t>
            </a:fld>
            <a:endParaRPr lang="el-G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l-G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323528" y="116632"/>
            <a:ext cx="1212191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600" b="1" dirty="0"/>
              <a:t>Suppl. Fig. 1</a:t>
            </a:r>
            <a:endParaRPr lang="el-GR" sz="1600" dirty="0"/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3040013080"/>
              </p:ext>
            </p:extLst>
          </p:nvPr>
        </p:nvGraphicFramePr>
        <p:xfrm>
          <a:off x="467544" y="1124745"/>
          <a:ext cx="8424938" cy="4608510"/>
        </p:xfrm>
        <a:graphic>
          <a:graphicData uri="http://schemas.openxmlformats.org/drawingml/2006/table">
            <a:tbl>
              <a:tblPr/>
              <a:tblGrid>
                <a:gridCol w="540705"/>
                <a:gridCol w="377236"/>
                <a:gridCol w="364662"/>
                <a:gridCol w="591004"/>
                <a:gridCol w="591004"/>
                <a:gridCol w="779621"/>
                <a:gridCol w="773333"/>
                <a:gridCol w="628727"/>
                <a:gridCol w="792195"/>
                <a:gridCol w="792195"/>
                <a:gridCol w="631870"/>
                <a:gridCol w="779621"/>
                <a:gridCol w="782765"/>
              </a:tblGrid>
              <a:tr h="229851"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Patients cohort</a:t>
                      </a:r>
                    </a:p>
                  </a:txBody>
                  <a:tcPr marL="7570" marR="7570" marT="75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Tumor status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l-G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l-GR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Before treatment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l-G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l-GR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After first cycle of treatment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l-G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l-GR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Progression of disease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l-G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l-GR"/>
                    </a:p>
                  </a:txBody>
                  <a:tcPr/>
                </a:tc>
              </a:tr>
              <a:tr h="459701">
                <a:tc vMerge="1">
                  <a:txBody>
                    <a:bodyPr/>
                    <a:lstStyle/>
                    <a:p>
                      <a:endParaRPr lang="el-G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ER </a:t>
                      </a:r>
                    </a:p>
                  </a:txBody>
                  <a:tcPr marL="7570" marR="7570" marT="757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PR </a:t>
                      </a:r>
                    </a:p>
                  </a:txBody>
                  <a:tcPr marL="7570" marR="7570" marT="757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HER2 </a:t>
                      </a:r>
                    </a:p>
                  </a:txBody>
                  <a:tcPr marL="7570" marR="7570" marT="757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1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PIK3CA </a:t>
                      </a: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E545K</a:t>
                      </a:r>
                    </a:p>
                  </a:txBody>
                  <a:tcPr marL="7570" marR="7570" marT="757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1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PIK3CA </a:t>
                      </a: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H1047R</a:t>
                      </a:r>
                    </a:p>
                  </a:txBody>
                  <a:tcPr marL="7570" marR="7570" marT="757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CellSearch®</a:t>
                      </a:r>
                    </a:p>
                    <a:p>
                      <a:pPr algn="ctr" fontAlgn="ctr"/>
                      <a:endParaRPr lang="en-US" sz="11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570" marR="7570" marT="757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1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PIK3CA </a:t>
                      </a: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E545K</a:t>
                      </a:r>
                    </a:p>
                  </a:txBody>
                  <a:tcPr marL="7570" marR="7570" marT="757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1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PIK3CA </a:t>
                      </a: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H1047R</a:t>
                      </a:r>
                    </a:p>
                  </a:txBody>
                  <a:tcPr marL="7570" marR="7570" marT="757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CellSearch®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7570" marR="7570" marT="757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1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PIK3CA</a:t>
                      </a: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E545K</a:t>
                      </a:r>
                    </a:p>
                  </a:txBody>
                  <a:tcPr marL="7570" marR="7570" marT="757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1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PIK3CA </a:t>
                      </a: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H1047R</a:t>
                      </a:r>
                    </a:p>
                  </a:txBody>
                  <a:tcPr marL="7570" marR="7570" marT="757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CellSearch®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570" marR="7570" marT="757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985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P1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</a:tr>
              <a:tr h="22985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2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8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</a:tr>
              <a:tr h="22985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3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</a:tr>
              <a:tr h="22985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P4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2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</a:tr>
              <a:tr h="22985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P5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970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876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550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</a:tr>
              <a:tr h="22985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6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1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</a:tr>
              <a:tr h="22985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7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94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8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4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</a:tr>
              <a:tr h="22985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P8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2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4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8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</a:tr>
              <a:tr h="22985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P9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</a:tr>
              <a:tr h="22985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10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1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</a:tr>
              <a:tr h="22985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P11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0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9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98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</a:tr>
              <a:tr h="22985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P12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588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171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</a:tr>
              <a:tr h="22985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P13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463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</a:tr>
              <a:tr h="22985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P14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1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4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</a:tr>
              <a:tr h="22985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P15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</a:tr>
              <a:tr h="22985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P16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</a:tr>
              <a:tr h="24134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P17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622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7570" marR="7570" marT="75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2</TotalTime>
  <Words>99</Words>
  <Application>Microsoft Office PowerPoint</Application>
  <PresentationFormat>On-screen Show (4:3)</PresentationFormat>
  <Paragraphs>23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CTC</dc:creator>
  <cp:lastModifiedBy>ACTC</cp:lastModifiedBy>
  <cp:revision>13</cp:revision>
  <dcterms:created xsi:type="dcterms:W3CDTF">2019-03-21T07:59:05Z</dcterms:created>
  <dcterms:modified xsi:type="dcterms:W3CDTF">2019-03-21T11:58:40Z</dcterms:modified>
</cp:coreProperties>
</file>